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sldIdLst>
    <p:sldId id="272" r:id="rId2"/>
  </p:sldIdLst>
  <p:sldSz cx="7772400" cy="10058400"/>
  <p:notesSz cx="7010400" cy="9296400"/>
  <p:defaultTextStyle>
    <a:defPPr>
      <a:defRPr lang="en-US"/>
    </a:defPPr>
    <a:lvl1pPr marL="0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1pPr>
    <a:lvl2pPr marL="286527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2pPr>
    <a:lvl3pPr marL="573054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3pPr>
    <a:lvl4pPr marL="859582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4pPr>
    <a:lvl5pPr marL="1146109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5pPr>
    <a:lvl6pPr marL="1432636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6pPr>
    <a:lvl7pPr marL="1719163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7pPr>
    <a:lvl8pPr marL="2005691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8pPr>
    <a:lvl9pPr marL="2292218" algn="l" defTabSz="573054" rtl="0" eaLnBrk="1" latinLnBrk="0" hangingPunct="1">
      <a:defRPr sz="112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6B3B6"/>
    <a:srgbClr val="2E2E2E"/>
    <a:srgbClr val="074207"/>
    <a:srgbClr val="4CB74C"/>
    <a:srgbClr val="4AC24A"/>
    <a:srgbClr val="797979"/>
    <a:srgbClr val="5FC95F"/>
    <a:srgbClr val="955FA8"/>
    <a:srgbClr val="7F7F7F"/>
    <a:srgbClr val="9A57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31" autoAdjust="0"/>
    <p:restoredTop sz="96206" autoAdjust="0"/>
  </p:normalViewPr>
  <p:slideViewPr>
    <p:cSldViewPr snapToGrid="0">
      <p:cViewPr varScale="1">
        <p:scale>
          <a:sx n="79" d="100"/>
          <a:sy n="79" d="100"/>
        </p:scale>
        <p:origin x="3060" y="9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ajga\AppData\Roaming\Microsoft\Windows\Network%20Shortcuts\Transduction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F7F7F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A30-4863-8CF7-E2EDA6006D3B}"/>
              </c:ext>
            </c:extLst>
          </c:dPt>
          <c:dPt>
            <c:idx val="1"/>
            <c:invertIfNegative val="0"/>
            <c:bubble3D val="0"/>
            <c:spPr>
              <a:solidFill>
                <a:srgbClr val="955FA8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A30-4863-8CF7-E2EDA6006D3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Q$14:$Q$15</c:f>
                <c:numCache>
                  <c:formatCode>General</c:formatCode>
                  <c:ptCount val="2"/>
                  <c:pt idx="0">
                    <c:v>0.6</c:v>
                  </c:pt>
                  <c:pt idx="1">
                    <c:v>7.54</c:v>
                  </c:pt>
                </c:numCache>
              </c:numRef>
            </c:plus>
            <c:minus>
              <c:numRef>
                <c:f>Sheet1!$Q$14:$Q$15</c:f>
                <c:numCache>
                  <c:formatCode>General</c:formatCode>
                  <c:ptCount val="2"/>
                  <c:pt idx="0">
                    <c:v>0.6</c:v>
                  </c:pt>
                  <c:pt idx="1">
                    <c:v>7.54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O$14:$O$15</c:f>
              <c:strCache>
                <c:ptCount val="2"/>
                <c:pt idx="0">
                  <c:v>NT </c:v>
                </c:pt>
                <c:pt idx="1">
                  <c:v>2G.4/7ICR</c:v>
                </c:pt>
              </c:strCache>
            </c:strRef>
          </c:cat>
          <c:val>
            <c:numRef>
              <c:f>Sheet1!$P$14:$P$15</c:f>
              <c:numCache>
                <c:formatCode>General</c:formatCode>
                <c:ptCount val="2"/>
                <c:pt idx="0">
                  <c:v>2.7850000000000001</c:v>
                </c:pt>
                <c:pt idx="1">
                  <c:v>71.01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A30-4863-8CF7-E2EDA6006D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5"/>
        <c:overlap val="-27"/>
        <c:axId val="388726552"/>
        <c:axId val="388727208"/>
      </c:barChart>
      <c:catAx>
        <c:axId val="388726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88727208"/>
        <c:crosses val="autoZero"/>
        <c:auto val="1"/>
        <c:lblAlgn val="ctr"/>
        <c:lblOffset val="100"/>
        <c:noMultiLvlLbl val="0"/>
      </c:catAx>
      <c:valAx>
        <c:axId val="388727208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388726552"/>
        <c:crosses val="autoZero"/>
        <c:crossBetween val="between"/>
      </c:valAx>
    </c:plotArea>
    <c:plotVisOnly val="1"/>
    <c:dispBlanksAs val="gap"/>
    <c:showDLblsOverMax val="0"/>
    <c:extLst/>
  </c:chart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4"/>
          </a:xfrm>
        </p:spPr>
        <p:txBody>
          <a:bodyPr anchor="b"/>
          <a:lstStyle>
            <a:lvl1pPr algn="ctr">
              <a:defRPr sz="8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352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70544" indent="0" algn="ctr">
              <a:buNone/>
              <a:defRPr sz="2934"/>
            </a:lvl2pPr>
            <a:lvl3pPr marL="1341087" indent="0" algn="ctr">
              <a:buNone/>
              <a:defRPr sz="2640"/>
            </a:lvl3pPr>
            <a:lvl4pPr marL="2011629" indent="0" algn="ctr">
              <a:buNone/>
              <a:defRPr sz="2346"/>
            </a:lvl4pPr>
            <a:lvl5pPr marL="2682173" indent="0" algn="ctr">
              <a:buNone/>
              <a:defRPr sz="2346"/>
            </a:lvl5pPr>
            <a:lvl6pPr marL="3352716" indent="0" algn="ctr">
              <a:buNone/>
              <a:defRPr sz="2346"/>
            </a:lvl6pPr>
            <a:lvl7pPr marL="4023260" indent="0" algn="ctr">
              <a:buNone/>
              <a:defRPr sz="2346"/>
            </a:lvl7pPr>
            <a:lvl8pPr marL="4693802" indent="0" algn="ctr">
              <a:buNone/>
              <a:defRPr sz="2346"/>
            </a:lvl8pPr>
            <a:lvl9pPr marL="5364346" indent="0" algn="ctr">
              <a:buNone/>
              <a:defRPr sz="234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2321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953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3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8"/>
            <a:ext cx="4930617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21615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7791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9"/>
            <a:ext cx="6703695" cy="4184014"/>
          </a:xfrm>
        </p:spPr>
        <p:txBody>
          <a:bodyPr anchor="b"/>
          <a:lstStyle>
            <a:lvl1pPr>
              <a:defRPr sz="8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3520">
                <a:solidFill>
                  <a:schemeClr val="tx1"/>
                </a:solidFill>
              </a:defRPr>
            </a:lvl1pPr>
            <a:lvl2pPr marL="670544" indent="0">
              <a:buNone/>
              <a:defRPr sz="2934">
                <a:solidFill>
                  <a:schemeClr val="tx1">
                    <a:tint val="75000"/>
                  </a:schemeClr>
                </a:solidFill>
              </a:defRPr>
            </a:lvl2pPr>
            <a:lvl3pPr marL="1341087" indent="0">
              <a:buNone/>
              <a:defRPr sz="2640">
                <a:solidFill>
                  <a:schemeClr val="tx1">
                    <a:tint val="75000"/>
                  </a:schemeClr>
                </a:solidFill>
              </a:defRPr>
            </a:lvl3pPr>
            <a:lvl4pPr marL="2011629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4pPr>
            <a:lvl5pPr marL="2682173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5pPr>
            <a:lvl6pPr marL="3352716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6pPr>
            <a:lvl7pPr marL="4023260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7pPr>
            <a:lvl8pPr marL="4693802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8pPr>
            <a:lvl9pPr marL="5364346" indent="0">
              <a:buNone/>
              <a:defRPr sz="23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0496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69224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7"/>
            <a:ext cx="3288089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44" indent="0">
              <a:buNone/>
              <a:defRPr sz="2934" b="1"/>
            </a:lvl2pPr>
            <a:lvl3pPr marL="1341087" indent="0">
              <a:buNone/>
              <a:defRPr sz="2640" b="1"/>
            </a:lvl3pPr>
            <a:lvl4pPr marL="2011629" indent="0">
              <a:buNone/>
              <a:defRPr sz="2346" b="1"/>
            </a:lvl4pPr>
            <a:lvl5pPr marL="2682173" indent="0">
              <a:buNone/>
              <a:defRPr sz="2346" b="1"/>
            </a:lvl5pPr>
            <a:lvl6pPr marL="3352716" indent="0">
              <a:buNone/>
              <a:defRPr sz="2346" b="1"/>
            </a:lvl6pPr>
            <a:lvl7pPr marL="4023260" indent="0">
              <a:buNone/>
              <a:defRPr sz="2346" b="1"/>
            </a:lvl7pPr>
            <a:lvl8pPr marL="4693802" indent="0">
              <a:buNone/>
              <a:defRPr sz="2346" b="1"/>
            </a:lvl8pPr>
            <a:lvl9pPr marL="5364346" indent="0">
              <a:buNone/>
              <a:defRPr sz="23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9" y="2465707"/>
            <a:ext cx="3304282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44" indent="0">
              <a:buNone/>
              <a:defRPr sz="2934" b="1"/>
            </a:lvl2pPr>
            <a:lvl3pPr marL="1341087" indent="0">
              <a:buNone/>
              <a:defRPr sz="2640" b="1"/>
            </a:lvl3pPr>
            <a:lvl4pPr marL="2011629" indent="0">
              <a:buNone/>
              <a:defRPr sz="2346" b="1"/>
            </a:lvl4pPr>
            <a:lvl5pPr marL="2682173" indent="0">
              <a:buNone/>
              <a:defRPr sz="2346" b="1"/>
            </a:lvl5pPr>
            <a:lvl6pPr marL="3352716" indent="0">
              <a:buNone/>
              <a:defRPr sz="2346" b="1"/>
            </a:lvl6pPr>
            <a:lvl7pPr marL="4023260" indent="0">
              <a:buNone/>
              <a:defRPr sz="2346" b="1"/>
            </a:lvl7pPr>
            <a:lvl8pPr marL="4693802" indent="0">
              <a:buNone/>
              <a:defRPr sz="2346" b="1"/>
            </a:lvl8pPr>
            <a:lvl9pPr marL="5364346" indent="0">
              <a:buNone/>
              <a:defRPr sz="234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9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0982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4991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9827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</p:spPr>
        <p:txBody>
          <a:bodyPr anchor="b"/>
          <a:lstStyle>
            <a:lvl1pPr>
              <a:defRPr sz="46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3" y="1448226"/>
            <a:ext cx="3934778" cy="7147984"/>
          </a:xfrm>
        </p:spPr>
        <p:txBody>
          <a:bodyPr/>
          <a:lstStyle>
            <a:lvl1pPr>
              <a:defRPr sz="4694"/>
            </a:lvl1pPr>
            <a:lvl2pPr>
              <a:defRPr sz="4106"/>
            </a:lvl2pPr>
            <a:lvl3pPr>
              <a:defRPr sz="3520"/>
            </a:lvl3pPr>
            <a:lvl4pPr>
              <a:defRPr sz="2934"/>
            </a:lvl4pPr>
            <a:lvl5pPr>
              <a:defRPr sz="2934"/>
            </a:lvl5pPr>
            <a:lvl6pPr>
              <a:defRPr sz="2934"/>
            </a:lvl6pPr>
            <a:lvl7pPr>
              <a:defRPr sz="2934"/>
            </a:lvl7pPr>
            <a:lvl8pPr>
              <a:defRPr sz="2934"/>
            </a:lvl8pPr>
            <a:lvl9pPr>
              <a:defRPr sz="29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2" cy="5590329"/>
          </a:xfrm>
        </p:spPr>
        <p:txBody>
          <a:bodyPr/>
          <a:lstStyle>
            <a:lvl1pPr marL="0" indent="0">
              <a:buNone/>
              <a:defRPr sz="2346"/>
            </a:lvl1pPr>
            <a:lvl2pPr marL="670544" indent="0">
              <a:buNone/>
              <a:defRPr sz="2054"/>
            </a:lvl2pPr>
            <a:lvl3pPr marL="1341087" indent="0">
              <a:buNone/>
              <a:defRPr sz="1760"/>
            </a:lvl3pPr>
            <a:lvl4pPr marL="2011629" indent="0">
              <a:buNone/>
              <a:defRPr sz="1466"/>
            </a:lvl4pPr>
            <a:lvl5pPr marL="2682173" indent="0">
              <a:buNone/>
              <a:defRPr sz="1466"/>
            </a:lvl5pPr>
            <a:lvl6pPr marL="3352716" indent="0">
              <a:buNone/>
              <a:defRPr sz="1466"/>
            </a:lvl6pPr>
            <a:lvl7pPr marL="4023260" indent="0">
              <a:buNone/>
              <a:defRPr sz="1466"/>
            </a:lvl7pPr>
            <a:lvl8pPr marL="4693802" indent="0">
              <a:buNone/>
              <a:defRPr sz="1466"/>
            </a:lvl8pPr>
            <a:lvl9pPr marL="5364346" indent="0">
              <a:buNone/>
              <a:defRPr sz="146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202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2" cy="2346960"/>
          </a:xfrm>
        </p:spPr>
        <p:txBody>
          <a:bodyPr anchor="b"/>
          <a:lstStyle>
            <a:lvl1pPr>
              <a:defRPr sz="46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3" y="1448226"/>
            <a:ext cx="3934778" cy="7147984"/>
          </a:xfrm>
        </p:spPr>
        <p:txBody>
          <a:bodyPr anchor="t"/>
          <a:lstStyle>
            <a:lvl1pPr marL="0" indent="0">
              <a:buNone/>
              <a:defRPr sz="4694"/>
            </a:lvl1pPr>
            <a:lvl2pPr marL="670544" indent="0">
              <a:buNone/>
              <a:defRPr sz="4106"/>
            </a:lvl2pPr>
            <a:lvl3pPr marL="1341087" indent="0">
              <a:buNone/>
              <a:defRPr sz="3520"/>
            </a:lvl3pPr>
            <a:lvl4pPr marL="2011629" indent="0">
              <a:buNone/>
              <a:defRPr sz="2934"/>
            </a:lvl4pPr>
            <a:lvl5pPr marL="2682173" indent="0">
              <a:buNone/>
              <a:defRPr sz="2934"/>
            </a:lvl5pPr>
            <a:lvl6pPr marL="3352716" indent="0">
              <a:buNone/>
              <a:defRPr sz="2934"/>
            </a:lvl6pPr>
            <a:lvl7pPr marL="4023260" indent="0">
              <a:buNone/>
              <a:defRPr sz="2934"/>
            </a:lvl7pPr>
            <a:lvl8pPr marL="4693802" indent="0">
              <a:buNone/>
              <a:defRPr sz="2934"/>
            </a:lvl8pPr>
            <a:lvl9pPr marL="5364346" indent="0">
              <a:buNone/>
              <a:defRPr sz="293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2" cy="5590329"/>
          </a:xfrm>
        </p:spPr>
        <p:txBody>
          <a:bodyPr/>
          <a:lstStyle>
            <a:lvl1pPr marL="0" indent="0">
              <a:buNone/>
              <a:defRPr sz="2346"/>
            </a:lvl1pPr>
            <a:lvl2pPr marL="670544" indent="0">
              <a:buNone/>
              <a:defRPr sz="2054"/>
            </a:lvl2pPr>
            <a:lvl3pPr marL="1341087" indent="0">
              <a:buNone/>
              <a:defRPr sz="1760"/>
            </a:lvl3pPr>
            <a:lvl4pPr marL="2011629" indent="0">
              <a:buNone/>
              <a:defRPr sz="1466"/>
            </a:lvl4pPr>
            <a:lvl5pPr marL="2682173" indent="0">
              <a:buNone/>
              <a:defRPr sz="1466"/>
            </a:lvl5pPr>
            <a:lvl6pPr marL="3352716" indent="0">
              <a:buNone/>
              <a:defRPr sz="1466"/>
            </a:lvl6pPr>
            <a:lvl7pPr marL="4023260" indent="0">
              <a:buNone/>
              <a:defRPr sz="1466"/>
            </a:lvl7pPr>
            <a:lvl8pPr marL="4693802" indent="0">
              <a:buNone/>
              <a:defRPr sz="1466"/>
            </a:lvl8pPr>
            <a:lvl9pPr marL="5364346" indent="0">
              <a:buNone/>
              <a:defRPr sz="146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885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4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4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0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005840"/>
            <a:fld id="{A2D542F7-2E2A-4FAC-A53B-04A68E3FCB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1005840"/>
              <a:t>4/15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9" y="9322650"/>
            <a:ext cx="2623185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005840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50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1005840"/>
            <a:fld id="{1A332394-BDD5-46F0-B185-58AEB7CF5FB8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1005840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28727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defTabSz="1341087" rtl="0" eaLnBrk="1" latinLnBrk="0" hangingPunct="1">
        <a:lnSpc>
          <a:spcPct val="90000"/>
        </a:lnSpc>
        <a:spcBef>
          <a:spcPct val="0"/>
        </a:spcBef>
        <a:buNone/>
        <a:defRPr sz="645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5271" indent="-335271" algn="l" defTabSz="1341087" rtl="0" eaLnBrk="1" latinLnBrk="0" hangingPunct="1">
        <a:lnSpc>
          <a:spcPct val="90000"/>
        </a:lnSpc>
        <a:spcBef>
          <a:spcPts val="1466"/>
        </a:spcBef>
        <a:buFont typeface="Arial" panose="020B0604020202020204" pitchFamily="34" charset="0"/>
        <a:buChar char="•"/>
        <a:defRPr sz="4106" kern="1200">
          <a:solidFill>
            <a:schemeClr val="tx1"/>
          </a:solidFill>
          <a:latin typeface="+mn-lt"/>
          <a:ea typeface="+mn-ea"/>
          <a:cs typeface="+mn-cs"/>
        </a:defRPr>
      </a:lvl1pPr>
      <a:lvl2pPr marL="1005815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3520" kern="1200">
          <a:solidFill>
            <a:schemeClr val="tx1"/>
          </a:solidFill>
          <a:latin typeface="+mn-lt"/>
          <a:ea typeface="+mn-ea"/>
          <a:cs typeface="+mn-cs"/>
        </a:defRPr>
      </a:lvl2pPr>
      <a:lvl3pPr marL="1676358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934" kern="1200">
          <a:solidFill>
            <a:schemeClr val="tx1"/>
          </a:solidFill>
          <a:latin typeface="+mn-lt"/>
          <a:ea typeface="+mn-ea"/>
          <a:cs typeface="+mn-cs"/>
        </a:defRPr>
      </a:lvl3pPr>
      <a:lvl4pPr marL="2346902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3017444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687988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358531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5029075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699617" indent="-335271" algn="l" defTabSz="1341087" rtl="0" eaLnBrk="1" latinLnBrk="0" hangingPunct="1">
        <a:lnSpc>
          <a:spcPct val="90000"/>
        </a:lnSpc>
        <a:spcBef>
          <a:spcPts val="734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1pPr>
      <a:lvl2pPr marL="670544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341087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3pPr>
      <a:lvl4pPr marL="2011629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2682173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023260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4693802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364346" algn="l" defTabSz="1341087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2" name="Chart 181">
            <a:extLst>
              <a:ext uri="{FF2B5EF4-FFF2-40B4-BE49-F238E27FC236}">
                <a16:creationId xmlns:a16="http://schemas.microsoft.com/office/drawing/2014/main" id="{3F1FF631-F58C-482C-B7D1-F415DB0ABA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248679"/>
              </p:ext>
            </p:extLst>
          </p:nvPr>
        </p:nvGraphicFramePr>
        <p:xfrm>
          <a:off x="4653714" y="2012951"/>
          <a:ext cx="2422860" cy="2458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5" name="Line 11"/>
          <p:cNvSpPr>
            <a:spLocks noChangeShapeType="1"/>
          </p:cNvSpPr>
          <p:nvPr/>
        </p:nvSpPr>
        <p:spPr bwMode="auto">
          <a:xfrm>
            <a:off x="1694297" y="1369763"/>
            <a:ext cx="0" cy="16401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Line 11"/>
          <p:cNvSpPr>
            <a:spLocks noChangeShapeType="1"/>
          </p:cNvSpPr>
          <p:nvPr/>
        </p:nvSpPr>
        <p:spPr bwMode="auto">
          <a:xfrm>
            <a:off x="3058387" y="1369763"/>
            <a:ext cx="0" cy="16401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Line 11"/>
          <p:cNvSpPr>
            <a:spLocks noChangeShapeType="1"/>
          </p:cNvSpPr>
          <p:nvPr/>
        </p:nvSpPr>
        <p:spPr bwMode="auto">
          <a:xfrm>
            <a:off x="4160966" y="1369763"/>
            <a:ext cx="0" cy="16401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Line 11"/>
          <p:cNvSpPr>
            <a:spLocks noChangeShapeType="1"/>
          </p:cNvSpPr>
          <p:nvPr/>
        </p:nvSpPr>
        <p:spPr bwMode="auto">
          <a:xfrm>
            <a:off x="4660058" y="1369763"/>
            <a:ext cx="0" cy="16401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Line 11"/>
          <p:cNvSpPr>
            <a:spLocks noChangeShapeType="1"/>
          </p:cNvSpPr>
          <p:nvPr/>
        </p:nvSpPr>
        <p:spPr bwMode="auto">
          <a:xfrm>
            <a:off x="5229222" y="1369763"/>
            <a:ext cx="0" cy="164010"/>
          </a:xfrm>
          <a:prstGeom prst="line">
            <a:avLst/>
          </a:prstGeom>
          <a:noFill/>
          <a:ln w="206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Line 34"/>
          <p:cNvSpPr>
            <a:spLocks noChangeShapeType="1"/>
          </p:cNvSpPr>
          <p:nvPr/>
        </p:nvSpPr>
        <p:spPr bwMode="auto">
          <a:xfrm flipV="1">
            <a:off x="4215188" y="985820"/>
            <a:ext cx="849385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13"/>
          <p:cNvSpPr>
            <a:spLocks noChangeShapeType="1"/>
          </p:cNvSpPr>
          <p:nvPr/>
        </p:nvSpPr>
        <p:spPr bwMode="auto">
          <a:xfrm flipH="1">
            <a:off x="1003193" y="1296319"/>
            <a:ext cx="5704120" cy="0"/>
          </a:xfrm>
          <a:prstGeom prst="line">
            <a:avLst/>
          </a:prstGeom>
          <a:noFill/>
          <a:ln w="25400" cap="flat">
            <a:solidFill>
              <a:srgbClr val="A6A6A6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17"/>
          <p:cNvSpPr>
            <a:spLocks noChangeArrowheads="1"/>
          </p:cNvSpPr>
          <p:nvPr/>
        </p:nvSpPr>
        <p:spPr bwMode="auto">
          <a:xfrm>
            <a:off x="516113" y="1198250"/>
            <a:ext cx="465833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srgbClr val="000000"/>
                </a:solidFill>
                <a:cs typeface="Arial" panose="020B0604020202020204" pitchFamily="34" charset="0"/>
              </a:rPr>
              <a:t>5’ LTR</a:t>
            </a:r>
            <a:endParaRPr lang="en-US" altLang="en-US" sz="1282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5" name="Rectangle 18"/>
          <p:cNvSpPr>
            <a:spLocks noChangeArrowheads="1"/>
          </p:cNvSpPr>
          <p:nvPr/>
        </p:nvSpPr>
        <p:spPr bwMode="auto">
          <a:xfrm>
            <a:off x="6724997" y="1198250"/>
            <a:ext cx="471924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srgbClr val="000000"/>
                </a:solidFill>
                <a:cs typeface="Arial" panose="020B0604020202020204" pitchFamily="34" charset="0"/>
              </a:rPr>
              <a:t>LTR 3’</a:t>
            </a:r>
            <a:endParaRPr lang="en-US" altLang="en-US" sz="1282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>
            <a:spLocks noChangeArrowheads="1"/>
          </p:cNvSpPr>
          <p:nvPr/>
        </p:nvSpPr>
        <p:spPr bwMode="auto">
          <a:xfrm>
            <a:off x="1233948" y="1111454"/>
            <a:ext cx="117020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l-GR" altLang="en-US" sz="1282" dirty="0">
                <a:solidFill>
                  <a:srgbClr val="000000"/>
                </a:solidFill>
                <a:cs typeface="Arial" panose="020B0604020202020204" pitchFamily="34" charset="0"/>
              </a:rPr>
              <a:t>ψ</a:t>
            </a:r>
            <a:endParaRPr lang="en-US" altLang="en-US" sz="1282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8" name="Line 34"/>
          <p:cNvSpPr>
            <a:spLocks noChangeShapeType="1"/>
          </p:cNvSpPr>
          <p:nvPr/>
        </p:nvSpPr>
        <p:spPr bwMode="auto">
          <a:xfrm>
            <a:off x="1941314" y="985820"/>
            <a:ext cx="2158442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35"/>
          <p:cNvSpPr>
            <a:spLocks noChangeArrowheads="1"/>
          </p:cNvSpPr>
          <p:nvPr/>
        </p:nvSpPr>
        <p:spPr bwMode="auto">
          <a:xfrm>
            <a:off x="5090451" y="1184428"/>
            <a:ext cx="274226" cy="235544"/>
          </a:xfrm>
          <a:prstGeom prst="rect">
            <a:avLst/>
          </a:prstGeom>
          <a:solidFill>
            <a:srgbClr val="D9D9D9"/>
          </a:solidFill>
          <a:ln>
            <a:noFill/>
          </a:ln>
          <a:extLs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Line 36"/>
          <p:cNvSpPr>
            <a:spLocks noChangeShapeType="1"/>
          </p:cNvSpPr>
          <p:nvPr/>
        </p:nvSpPr>
        <p:spPr bwMode="auto">
          <a:xfrm>
            <a:off x="1940967" y="915960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Line 38"/>
          <p:cNvSpPr>
            <a:spLocks noChangeShapeType="1"/>
          </p:cNvSpPr>
          <p:nvPr/>
        </p:nvSpPr>
        <p:spPr bwMode="auto">
          <a:xfrm flipV="1">
            <a:off x="4100028" y="904768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39"/>
          <p:cNvSpPr>
            <a:spLocks noChangeArrowheads="1"/>
          </p:cNvSpPr>
          <p:nvPr/>
        </p:nvSpPr>
        <p:spPr bwMode="auto">
          <a:xfrm>
            <a:off x="5113049" y="1201566"/>
            <a:ext cx="237244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srgbClr val="000000"/>
                </a:solidFill>
                <a:cs typeface="Arial" panose="020B0604020202020204" pitchFamily="34" charset="0"/>
              </a:rPr>
              <a:t>TM</a:t>
            </a:r>
            <a:endParaRPr lang="en-US" altLang="en-US" sz="1282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3" name="Line 36"/>
          <p:cNvSpPr>
            <a:spLocks noChangeShapeType="1"/>
          </p:cNvSpPr>
          <p:nvPr/>
        </p:nvSpPr>
        <p:spPr bwMode="auto">
          <a:xfrm>
            <a:off x="4215187" y="905688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Line 38"/>
          <p:cNvSpPr>
            <a:spLocks noChangeShapeType="1"/>
          </p:cNvSpPr>
          <p:nvPr/>
        </p:nvSpPr>
        <p:spPr bwMode="auto">
          <a:xfrm flipV="1">
            <a:off x="5064007" y="908793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23"/>
          <p:cNvSpPr>
            <a:spLocks noChangeArrowheads="1"/>
          </p:cNvSpPr>
          <p:nvPr/>
        </p:nvSpPr>
        <p:spPr bwMode="auto">
          <a:xfrm>
            <a:off x="1486437" y="1184428"/>
            <a:ext cx="437693" cy="235544"/>
          </a:xfrm>
          <a:prstGeom prst="rect">
            <a:avLst/>
          </a:prstGeom>
          <a:solidFill>
            <a:srgbClr val="D9D9D9"/>
          </a:solidFill>
          <a:ln>
            <a:noFill/>
          </a:ln>
          <a:extLs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24"/>
          <p:cNvSpPr>
            <a:spLocks noChangeArrowheads="1"/>
          </p:cNvSpPr>
          <p:nvPr/>
        </p:nvSpPr>
        <p:spPr bwMode="auto">
          <a:xfrm>
            <a:off x="1541394" y="1201566"/>
            <a:ext cx="328616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srgbClr val="000000"/>
                </a:solidFill>
                <a:cs typeface="Arial" panose="020B0604020202020204" pitchFamily="34" charset="0"/>
              </a:rPr>
              <a:t>LDR</a:t>
            </a:r>
            <a:endParaRPr lang="en-US" altLang="en-US" sz="1282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8" name="Rectangle 61"/>
          <p:cNvSpPr>
            <a:spLocks noChangeArrowheads="1"/>
          </p:cNvSpPr>
          <p:nvPr/>
        </p:nvSpPr>
        <p:spPr bwMode="auto">
          <a:xfrm>
            <a:off x="1202364" y="1545322"/>
            <a:ext cx="955390" cy="147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961" dirty="0">
                <a:solidFill>
                  <a:srgbClr val="000000"/>
                </a:solidFill>
                <a:cs typeface="Arial" panose="020B0604020202020204" pitchFamily="34" charset="0"/>
              </a:rPr>
              <a:t>Leader sequence</a:t>
            </a:r>
            <a:endParaRPr lang="en-US" altLang="en-US" sz="96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9" name="Rectangle 87"/>
          <p:cNvSpPr>
            <a:spLocks noChangeAspect="1"/>
          </p:cNvSpPr>
          <p:nvPr/>
        </p:nvSpPr>
        <p:spPr>
          <a:xfrm>
            <a:off x="1950892" y="1184428"/>
            <a:ext cx="1046051" cy="235544"/>
          </a:xfrm>
          <a:prstGeom prst="rect">
            <a:avLst/>
          </a:prstGeom>
          <a:solidFill>
            <a:srgbClr val="5A5A5A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88"/>
          <p:cNvSpPr>
            <a:spLocks noChangeAspect="1"/>
          </p:cNvSpPr>
          <p:nvPr/>
        </p:nvSpPr>
        <p:spPr>
          <a:xfrm>
            <a:off x="3023704" y="1184428"/>
            <a:ext cx="70186" cy="235544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89"/>
          <p:cNvSpPr>
            <a:spLocks noChangeAspect="1"/>
          </p:cNvSpPr>
          <p:nvPr/>
        </p:nvSpPr>
        <p:spPr>
          <a:xfrm>
            <a:off x="3120649" y="1184428"/>
            <a:ext cx="981207" cy="235544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 90"/>
          <p:cNvSpPr>
            <a:spLocks/>
          </p:cNvSpPr>
          <p:nvPr/>
        </p:nvSpPr>
        <p:spPr>
          <a:xfrm>
            <a:off x="4128618" y="1184428"/>
            <a:ext cx="62979" cy="235544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90"/>
          <p:cNvSpPr>
            <a:spLocks/>
          </p:cNvSpPr>
          <p:nvPr/>
        </p:nvSpPr>
        <p:spPr>
          <a:xfrm>
            <a:off x="4218359" y="1184428"/>
            <a:ext cx="845330" cy="235544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86"/>
          <p:cNvSpPr>
            <a:spLocks noChangeAspect="1"/>
          </p:cNvSpPr>
          <p:nvPr/>
        </p:nvSpPr>
        <p:spPr>
          <a:xfrm>
            <a:off x="5943517" y="1184428"/>
            <a:ext cx="601380" cy="235544"/>
          </a:xfrm>
          <a:prstGeom prst="rect">
            <a:avLst/>
          </a:prstGeom>
          <a:solidFill>
            <a:srgbClr val="FF0000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Line 34"/>
          <p:cNvSpPr>
            <a:spLocks noChangeShapeType="1"/>
          </p:cNvSpPr>
          <p:nvPr/>
        </p:nvSpPr>
        <p:spPr bwMode="auto">
          <a:xfrm flipV="1">
            <a:off x="5395186" y="985819"/>
            <a:ext cx="1139492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Line 36"/>
          <p:cNvSpPr>
            <a:spLocks noChangeShapeType="1"/>
          </p:cNvSpPr>
          <p:nvPr/>
        </p:nvSpPr>
        <p:spPr bwMode="auto">
          <a:xfrm>
            <a:off x="5393163" y="915960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Line 38"/>
          <p:cNvSpPr>
            <a:spLocks noChangeShapeType="1"/>
          </p:cNvSpPr>
          <p:nvPr/>
        </p:nvSpPr>
        <p:spPr bwMode="auto">
          <a:xfrm flipH="1" flipV="1">
            <a:off x="6531537" y="904768"/>
            <a:ext cx="0" cy="164744"/>
          </a:xfrm>
          <a:prstGeom prst="line">
            <a:avLst/>
          </a:prstGeom>
          <a:noFill/>
          <a:ln w="285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vert="horz" wrap="square" lIns="97626" tIns="48813" rIns="97626" bIns="48813" numCol="1" anchor="t" anchorCtr="0" compatLnSpc="1">
            <a:prstTxWarp prst="textNoShape">
              <a:avLst/>
            </a:prstTxWarp>
          </a:bodyPr>
          <a:lstStyle/>
          <a:p>
            <a:pPr defTabSz="1005840"/>
            <a:endParaRPr lang="en-US" sz="1282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4"/>
          <p:cNvSpPr txBox="1"/>
          <p:nvPr/>
        </p:nvSpPr>
        <p:spPr>
          <a:xfrm>
            <a:off x="2875528" y="1545322"/>
            <a:ext cx="336631" cy="1478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 defTabSz="1005840"/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inker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テキスト ボックス 77"/>
          <p:cNvSpPr txBox="1"/>
          <p:nvPr/>
        </p:nvSpPr>
        <p:spPr>
          <a:xfrm>
            <a:off x="5051092" y="1545322"/>
            <a:ext cx="317395" cy="1478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 defTabSz="1005840"/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D28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テキスト ボックス 76"/>
          <p:cNvSpPr txBox="1"/>
          <p:nvPr/>
        </p:nvSpPr>
        <p:spPr>
          <a:xfrm>
            <a:off x="4519148" y="1545322"/>
            <a:ext cx="248466" cy="1478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 defTabSz="1005840"/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H3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テキスト ボックス 76"/>
          <p:cNvSpPr txBox="1"/>
          <p:nvPr/>
        </p:nvSpPr>
        <p:spPr>
          <a:xfrm>
            <a:off x="3993482" y="1545322"/>
            <a:ext cx="323807" cy="14786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 defTabSz="1005840"/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Hinge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2234265" y="921871"/>
            <a:ext cx="1582164" cy="141064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 defTabSz="1005840">
              <a:lnSpc>
                <a:spcPts val="1068"/>
              </a:lnSpc>
            </a:pPr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ntigen binding domain </a:t>
            </a:r>
            <a:r>
              <a:rPr kumimoji="1" lang="en-US" altLang="ja-JP" sz="961" dirty="0" err="1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cFv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テキスト ボックス 88"/>
          <p:cNvSpPr txBox="1"/>
          <p:nvPr/>
        </p:nvSpPr>
        <p:spPr>
          <a:xfrm>
            <a:off x="5479327" y="921871"/>
            <a:ext cx="967046" cy="14106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 defTabSz="1005840">
              <a:lnSpc>
                <a:spcPts val="1068"/>
              </a:lnSpc>
            </a:pPr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ignaling domain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Rectangle 86"/>
          <p:cNvSpPr>
            <a:spLocks noChangeAspect="1"/>
          </p:cNvSpPr>
          <p:nvPr/>
        </p:nvSpPr>
        <p:spPr>
          <a:xfrm>
            <a:off x="5391439" y="1184428"/>
            <a:ext cx="525315" cy="235544"/>
          </a:xfrm>
          <a:prstGeom prst="rect">
            <a:avLst/>
          </a:prstGeom>
          <a:solidFill>
            <a:srgbClr val="0000CC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1282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692011" y="1936868"/>
            <a:ext cx="1752685" cy="355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005840"/>
            <a:r>
              <a:rPr lang="en-US" sz="170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2513340" y="1916071"/>
            <a:ext cx="1766414" cy="355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005840"/>
            <a:r>
              <a:rPr lang="en-US" sz="1708" dirty="0">
                <a:solidFill>
                  <a:srgbClr val="955FA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G.4/7ICR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695827" y="4012622"/>
            <a:ext cx="1804981" cy="26282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1708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range</a:t>
            </a:r>
            <a:r>
              <a:rPr lang="en-US" sz="170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4/7ICR)</a:t>
            </a:r>
          </a:p>
        </p:txBody>
      </p:sp>
      <p:sp>
        <p:nvSpPr>
          <p:cNvPr id="93" name="TextBox 92"/>
          <p:cNvSpPr txBox="1"/>
          <p:nvPr/>
        </p:nvSpPr>
        <p:spPr>
          <a:xfrm rot="16200000">
            <a:off x="-318563" y="2971898"/>
            <a:ext cx="1659429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05840"/>
            <a:r>
              <a:rPr lang="en-US" sz="1708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IgG (CAR)</a:t>
            </a:r>
          </a:p>
        </p:txBody>
      </p:sp>
      <p:cxnSp>
        <p:nvCxnSpPr>
          <p:cNvPr id="95" name="Straight Arrow Connector 94"/>
          <p:cNvCxnSpPr/>
          <p:nvPr/>
        </p:nvCxnSpPr>
        <p:spPr>
          <a:xfrm>
            <a:off x="2569277" y="4166646"/>
            <a:ext cx="162487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6458748" y="2053680"/>
            <a:ext cx="546946" cy="2771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defTabSz="1005840"/>
            <a:r>
              <a:rPr lang="en-US" sz="120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3515453" y="2958131"/>
            <a:ext cx="2164375" cy="3223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05840"/>
            <a:r>
              <a:rPr lang="en-US" sz="1495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 Double positive cells</a:t>
            </a:r>
          </a:p>
        </p:txBody>
      </p:sp>
      <p:sp>
        <p:nvSpPr>
          <p:cNvPr id="100" name="テキスト ボックス 88"/>
          <p:cNvSpPr txBox="1"/>
          <p:nvPr/>
        </p:nvSpPr>
        <p:spPr>
          <a:xfrm>
            <a:off x="4277524" y="852559"/>
            <a:ext cx="712925" cy="28212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 defTabSz="1005840">
              <a:lnSpc>
                <a:spcPts val="1068"/>
              </a:lnSpc>
            </a:pPr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pacer</a:t>
            </a:r>
          </a:p>
          <a:p>
            <a:pPr algn="ctr" defTabSz="1005840">
              <a:lnSpc>
                <a:spcPts val="1068"/>
              </a:lnSpc>
            </a:pPr>
            <a:r>
              <a:rPr kumimoji="1" lang="en-US" altLang="ja-JP" sz="96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IgG2-derived</a:t>
            </a:r>
            <a:endParaRPr kumimoji="1" lang="ja-JP" altLang="en-US" sz="96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Rectangle 24"/>
          <p:cNvSpPr>
            <a:spLocks noChangeArrowheads="1"/>
          </p:cNvSpPr>
          <p:nvPr/>
        </p:nvSpPr>
        <p:spPr bwMode="auto">
          <a:xfrm>
            <a:off x="2359838" y="1201566"/>
            <a:ext cx="227626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VH</a:t>
            </a:r>
          </a:p>
        </p:txBody>
      </p:sp>
      <p:sp>
        <p:nvSpPr>
          <p:cNvPr id="108" name="Rectangle 24"/>
          <p:cNvSpPr>
            <a:spLocks noChangeArrowheads="1"/>
          </p:cNvSpPr>
          <p:nvPr/>
        </p:nvSpPr>
        <p:spPr bwMode="auto">
          <a:xfrm>
            <a:off x="3491293" y="1201566"/>
            <a:ext cx="200376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VL</a:t>
            </a:r>
          </a:p>
        </p:txBody>
      </p:sp>
      <p:sp>
        <p:nvSpPr>
          <p:cNvPr id="109" name="Rectangle 24"/>
          <p:cNvSpPr>
            <a:spLocks noChangeArrowheads="1"/>
          </p:cNvSpPr>
          <p:nvPr/>
        </p:nvSpPr>
        <p:spPr bwMode="auto">
          <a:xfrm>
            <a:off x="4481588" y="1201566"/>
            <a:ext cx="328616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CH3</a:t>
            </a:r>
          </a:p>
        </p:txBody>
      </p:sp>
      <p:sp>
        <p:nvSpPr>
          <p:cNvPr id="110" name="Rectangle 24"/>
          <p:cNvSpPr>
            <a:spLocks noChangeArrowheads="1"/>
          </p:cNvSpPr>
          <p:nvPr/>
        </p:nvSpPr>
        <p:spPr bwMode="auto">
          <a:xfrm>
            <a:off x="5452895" y="1201566"/>
            <a:ext cx="400751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41BB</a:t>
            </a:r>
          </a:p>
        </p:txBody>
      </p:sp>
      <p:sp>
        <p:nvSpPr>
          <p:cNvPr id="111" name="Rectangle 24"/>
          <p:cNvSpPr>
            <a:spLocks noChangeArrowheads="1"/>
          </p:cNvSpPr>
          <p:nvPr/>
        </p:nvSpPr>
        <p:spPr bwMode="auto">
          <a:xfrm>
            <a:off x="6044942" y="1201566"/>
            <a:ext cx="400751" cy="1972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1005840"/>
            <a:r>
              <a:rPr lang="en-US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CD3</a:t>
            </a:r>
            <a:r>
              <a:rPr lang="el-GR" altLang="en-US" sz="1282" dirty="0">
                <a:solidFill>
                  <a:prstClr val="white"/>
                </a:solidFill>
                <a:cs typeface="Arial" panose="020B0604020202020204" pitchFamily="34" charset="0"/>
              </a:rPr>
              <a:t>ζ</a:t>
            </a:r>
            <a:endParaRPr lang="en-US" altLang="en-US" sz="1282" dirty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024917" y="2232563"/>
            <a:ext cx="252607" cy="170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678">
              <a:solidFill>
                <a:prstClr val="white"/>
              </a:solidFill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2180708" y="2245432"/>
            <a:ext cx="252607" cy="170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678">
              <a:solidFill>
                <a:prstClr val="white"/>
              </a:solidFill>
            </a:endParaRPr>
          </a:p>
        </p:txBody>
      </p:sp>
      <p:sp>
        <p:nvSpPr>
          <p:cNvPr id="118" name="Rectangle 117"/>
          <p:cNvSpPr/>
          <p:nvPr/>
        </p:nvSpPr>
        <p:spPr>
          <a:xfrm>
            <a:off x="2522398" y="2232563"/>
            <a:ext cx="252607" cy="170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678">
              <a:solidFill>
                <a:prstClr val="white"/>
              </a:solidFill>
            </a:endParaRPr>
          </a:p>
        </p:txBody>
      </p:sp>
      <p:sp>
        <p:nvSpPr>
          <p:cNvPr id="119" name="Rectangle 118"/>
          <p:cNvSpPr/>
          <p:nvPr/>
        </p:nvSpPr>
        <p:spPr>
          <a:xfrm>
            <a:off x="4024917" y="3768733"/>
            <a:ext cx="252607" cy="2062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005840"/>
            <a:endParaRPr lang="en-US" sz="678">
              <a:solidFill>
                <a:prstClr val="white"/>
              </a:solidFill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18411" y="1753388"/>
            <a:ext cx="270908" cy="32534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2114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318411" y="528692"/>
            <a:ext cx="270908" cy="32534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2114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pic>
        <p:nvPicPr>
          <p:cNvPr id="180" name="Picture 179">
            <a:extLst>
              <a:ext uri="{FF2B5EF4-FFF2-40B4-BE49-F238E27FC236}">
                <a16:creationId xmlns:a16="http://schemas.microsoft.com/office/drawing/2014/main" id="{18FF6ED0-4E79-446A-9297-EE515413845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980" y="2223352"/>
            <a:ext cx="1783080" cy="1783080"/>
          </a:xfrm>
          <a:prstGeom prst="rect">
            <a:avLst/>
          </a:prstGeom>
        </p:spPr>
      </p:pic>
      <p:pic>
        <p:nvPicPr>
          <p:cNvPr id="181" name="Picture 180">
            <a:extLst>
              <a:ext uri="{FF2B5EF4-FFF2-40B4-BE49-F238E27FC236}">
                <a16:creationId xmlns:a16="http://schemas.microsoft.com/office/drawing/2014/main" id="{12BF397B-52AC-410C-9718-DB5A8FD35D9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5007" y="2223352"/>
            <a:ext cx="1783080" cy="1783080"/>
          </a:xfrm>
          <a:prstGeom prst="rect">
            <a:avLst/>
          </a:prstGeom>
        </p:spPr>
      </p:pic>
      <p:sp>
        <p:nvSpPr>
          <p:cNvPr id="98" name="TextBox 97"/>
          <p:cNvSpPr txBox="1"/>
          <p:nvPr/>
        </p:nvSpPr>
        <p:spPr>
          <a:xfrm>
            <a:off x="2545520" y="2236048"/>
            <a:ext cx="498534" cy="262829"/>
          </a:xfrm>
          <a:prstGeom prst="rect">
            <a:avLst/>
          </a:prstGeom>
          <a:noFill/>
          <a:effectLst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1708" dirty="0">
                <a:solidFill>
                  <a:prstClr val="black">
                    <a:alpha val="99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6%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3748138" y="3721108"/>
            <a:ext cx="498534" cy="26282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1708" dirty="0">
                <a:solidFill>
                  <a:prstClr val="black">
                    <a:alpha val="99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8.7%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636638" y="2236048"/>
            <a:ext cx="620363" cy="26282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defTabSz="1005840"/>
            <a:r>
              <a:rPr lang="en-US" sz="1708" dirty="0">
                <a:solidFill>
                  <a:prstClr val="black">
                    <a:alpha val="99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77.4%</a:t>
            </a: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A2443464-8B4E-4CA7-9703-738A869DC420}"/>
              </a:ext>
            </a:extLst>
          </p:cNvPr>
          <p:cNvSpPr/>
          <p:nvPr/>
        </p:nvSpPr>
        <p:spPr>
          <a:xfrm>
            <a:off x="698157" y="5766759"/>
            <a:ext cx="637608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Generation of 2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ion CAR.MUC1 T cells</a:t>
            </a:r>
          </a:p>
          <a:p>
            <a:pPr algn="just">
              <a:lnSpc>
                <a:spcPct val="20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chematic of 2nd generation CAR.MUC1 (2G) retroviral construct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-expression of 4/7ICR and 2G CAR as detect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ang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nti-IgG, respectively. Summary data (right panel) shows percentage of double-positive cell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=4).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3D0B19B-1481-456F-B9D3-EC0DBF7E2886}"/>
              </a:ext>
            </a:extLst>
          </p:cNvPr>
          <p:cNvSpPr txBox="1"/>
          <p:nvPr/>
        </p:nvSpPr>
        <p:spPr>
          <a:xfrm>
            <a:off x="5554982" y="100714"/>
            <a:ext cx="211118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712701943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B8D7F507-B36B-482E-8E29-E703F200C8D1}" vid="{403536A6-D81A-438C-9A01-D90D636C2D5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98</TotalTime>
  <Words>130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3_Office Theme</vt:lpstr>
      <vt:lpstr>PowerPoint Presentation</vt:lpstr>
    </vt:vector>
  </TitlesOfParts>
  <Company>Texas Children's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winwung, Supannikar</dc:creator>
  <cp:lastModifiedBy>Bajgain, Pradip</cp:lastModifiedBy>
  <cp:revision>229</cp:revision>
  <cp:lastPrinted>2017-11-09T19:56:25Z</cp:lastPrinted>
  <dcterms:created xsi:type="dcterms:W3CDTF">2016-11-08T14:43:17Z</dcterms:created>
  <dcterms:modified xsi:type="dcterms:W3CDTF">2018-04-16T03:31:02Z</dcterms:modified>
</cp:coreProperties>
</file>